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56" r:id="rId2"/>
    <p:sldId id="264" r:id="rId3"/>
    <p:sldId id="267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FBFBF"/>
    <a:srgbClr val="F2F2F2"/>
    <a:srgbClr val="E2F0D9"/>
    <a:srgbClr val="DEEBF7"/>
    <a:srgbClr val="FF0000"/>
    <a:srgbClr val="DAE3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4843"/>
    <p:restoredTop sz="94673"/>
  </p:normalViewPr>
  <p:slideViewPr>
    <p:cSldViewPr snapToGrid="0" snapToObjects="1">
      <p:cViewPr varScale="1">
        <p:scale>
          <a:sx n="78" d="100"/>
          <a:sy n="78" d="100"/>
        </p:scale>
        <p:origin x="176" y="8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napToObjects="1">
      <p:cViewPr varScale="1">
        <p:scale>
          <a:sx n="87" d="100"/>
          <a:sy n="87" d="100"/>
        </p:scale>
        <p:origin x="3216" y="200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733866E-3DFB-D84A-AAC9-59E5DBDB18AE}" type="datetimeFigureOut">
              <a:rPr lang="en-US" smtClean="0"/>
              <a:t>5/1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8F5C380-FE21-4141-A1CA-4AC9565DDC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6397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8F5C380-FE21-4141-A1CA-4AC9565DDC8B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93995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C1D4F7-2A6D-E349-8904-3B3BAAFAFEE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815935D-BC47-9249-BB9B-3BF74B5219E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A66035-8CC4-264B-9D44-CEBEB010AD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14920-506D-054A-9B46-B083A88807F0}" type="datetimeFigureOut">
              <a:rPr lang="en-US" smtClean="0"/>
              <a:t>5/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3D3091-711F-E040-9DCF-2A40155A78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8CED2A-2997-6A42-BA79-C3558B55F7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B9391-CFAD-3E4E-B042-011B8DF9F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32015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6C4ADA-3021-8B40-B603-31F31F3E88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5DFB317-A915-E14D-B5BC-A464E56DEC0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992AF3-07CB-7B4B-BF0A-A3C6E56A5C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14920-506D-054A-9B46-B083A88807F0}" type="datetimeFigureOut">
              <a:rPr lang="en-US" smtClean="0"/>
              <a:t>5/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A62D05-D456-724E-8193-12DC60486C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D93548-1B67-984C-BA43-81E6E24ED5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B9391-CFAD-3E4E-B042-011B8DF9F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97515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AF01A74-5C27-5A44-A310-178FAD00B1F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0D9A2EF-A8EC-B546-B6B2-AE16F16B68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065D47-0B7F-104C-97D1-FA8313C202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14920-506D-054A-9B46-B083A88807F0}" type="datetimeFigureOut">
              <a:rPr lang="en-US" smtClean="0"/>
              <a:t>5/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E62E46-52A6-914F-8366-24A7A3CA46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AE3D58-BF11-B84C-BFE6-32AB4D81EF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B9391-CFAD-3E4E-B042-011B8DF9F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5610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9BD70B-E835-8045-A982-83F8593EEE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324D29-EB34-034B-ABC1-69561B1DF58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9482E3-7F54-5F48-BE67-52882086F0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14920-506D-054A-9B46-B083A88807F0}" type="datetimeFigureOut">
              <a:rPr lang="en-US" smtClean="0"/>
              <a:t>5/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D34D31-64A5-894C-89BB-DE594BDACA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46244E-074E-8A43-BC39-9F1B99B406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B9391-CFAD-3E4E-B042-011B8DF9F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2181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5D4E33-F018-3F4F-805C-DB9996AE33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2D539B-0243-5145-8E24-CDD0EA3C31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4E00C8-67B9-7A4A-93BB-2DB2C76890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14920-506D-054A-9B46-B083A88807F0}" type="datetimeFigureOut">
              <a:rPr lang="en-US" smtClean="0"/>
              <a:t>5/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CE2074-FC55-9D4F-97ED-69ABD5F61C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07071F-65E0-A347-8BEB-7CE1DB88E2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B9391-CFAD-3E4E-B042-011B8DF9F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17921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8B8978-829C-9F4B-9A64-BDED368CFC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09DAEA-75E7-9748-BCAD-4749F056CF7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BD0B669-C272-9A47-867F-3D0B5BB107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9C62C2D-3DFC-BB4C-AF2C-287377A1DB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14920-506D-054A-9B46-B083A88807F0}" type="datetimeFigureOut">
              <a:rPr lang="en-US" smtClean="0"/>
              <a:t>5/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5EC8353-077A-8C49-98AD-F6F074FB10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0222726-163E-A24A-847E-6394F36B0E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B9391-CFAD-3E4E-B042-011B8DF9F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74784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F68413-B524-8140-80E0-22988644A6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D99B2DB-4B2E-1B48-8C69-9F32C648F4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4AF6A62-CFD0-9642-BACE-4FA749A1FD7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D8D910F-070E-474C-8A05-9D777B1346E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94415CF-A0B8-A244-B1E7-170763060C3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2C1649B-F20D-B044-84B2-78EC303AA9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14920-506D-054A-9B46-B083A88807F0}" type="datetimeFigureOut">
              <a:rPr lang="en-US" smtClean="0"/>
              <a:t>5/1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9EF6752-35A1-4149-B6BA-FAE266DBDA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CE1BAED-3A3B-8E41-AB54-2810CF9FE2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B9391-CFAD-3E4E-B042-011B8DF9F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16027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049F1B-6970-BC4C-ADF0-D1B8BA99A1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1D38509-31B4-2B41-869A-EEDB05FDA1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14920-506D-054A-9B46-B083A88807F0}" type="datetimeFigureOut">
              <a:rPr lang="en-US" smtClean="0"/>
              <a:t>5/1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71CA151-E6EA-5D41-9F4B-270A84C561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146C79B-ED55-EE45-9095-2991D4201A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B9391-CFAD-3E4E-B042-011B8DF9F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55256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43801F0-BE14-4E4F-B224-44B872297F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14920-506D-054A-9B46-B083A88807F0}" type="datetimeFigureOut">
              <a:rPr lang="en-US" smtClean="0"/>
              <a:t>5/1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35B4AD9-30C3-0A43-B8CC-D23DFCCEA8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F87CFF7-BAF7-CE47-A1B7-E08A15331D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B9391-CFAD-3E4E-B042-011B8DF9F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1861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072ACA-8A27-8041-9C84-6C6A1D7BE0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9C7D8D-BFB3-804E-8889-C2B727EBF4E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CAFC77D-0F58-0141-9B69-47BAF46311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84D2EC7-2790-5543-86ED-97792303AE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14920-506D-054A-9B46-B083A88807F0}" type="datetimeFigureOut">
              <a:rPr lang="en-US" smtClean="0"/>
              <a:t>5/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5D40089-C80A-A14F-B7DE-6C8C0728FE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F612518-9B64-F640-92EB-15EF13257B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B9391-CFAD-3E4E-B042-011B8DF9F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7021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2FA41C-66F8-0C4C-8601-1E52AAF49F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0BD1286-8B96-2D43-849E-2505C802177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71294E7-9EE2-8243-8A06-63B4818C10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64444B2-498F-A147-B5B6-31BCC8D22E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C14920-506D-054A-9B46-B083A88807F0}" type="datetimeFigureOut">
              <a:rPr lang="en-US" smtClean="0"/>
              <a:t>5/1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0F67BD-EA7A-A140-A10A-265C3DF044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1E9D86-8158-1241-B925-B63F2E5706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6B9391-CFAD-3E4E-B042-011B8DF9F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98326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CA1A5E0-17EF-5340-BA7A-EDEC83E1B5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5A8CFF8-C512-E948-98D6-F5E8AA3B5A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586355-2013-174A-92E0-7AD53A95274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C14920-506D-054A-9B46-B083A88807F0}" type="datetimeFigureOut">
              <a:rPr lang="en-US" smtClean="0"/>
              <a:t>5/1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6A2421-A656-A142-9DA0-242356C4BFA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6BB34B-901C-854E-A8CB-32FE4800D19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6B9391-CFAD-3E4E-B042-011B8DF9F3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69742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00F50B-AF11-8640-80F0-55A089989758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upplementary Figures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4F61737-EEA2-B041-A202-AD97CD7C70F9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Metabolic Dysfunction and Obesity-Related Cancer: Results from the Cross-Sectional National Health and Nutrition Examination Survey</a:t>
            </a:r>
          </a:p>
        </p:txBody>
      </p:sp>
    </p:spTree>
    <p:extLst>
      <p:ext uri="{BB962C8B-B14F-4D97-AF65-F5344CB8AC3E}">
        <p14:creationId xmlns:p14="http://schemas.microsoft.com/office/powerpoint/2010/main" val="27498453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520E13F-A234-0440-895E-4246BE016E0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393700"/>
            <a:ext cx="10515600" cy="5783263"/>
          </a:xfrm>
        </p:spPr>
        <p:txBody>
          <a:bodyPr>
            <a:normAutofit/>
          </a:bodyPr>
          <a:lstStyle/>
          <a:p>
            <a:pPr marL="0" indent="0">
              <a:lnSpc>
                <a:spcPct val="200000"/>
              </a:lnSpc>
              <a:spcBef>
                <a:spcPts val="0"/>
              </a:spcBef>
              <a:buNone/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: Adjusted odds ratios and 95% confidence intervals for risk of obesity-related cancer with abnormal metabolic syndrome parameters, overall and by cancer site in National Health and Nutrition Examination Survey participants 1999-2018 (N = 19,500)</a:t>
            </a:r>
            <a:r>
              <a:rPr lang="en-US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marL="0" indent="0">
              <a:lnSpc>
                <a:spcPct val="200000"/>
              </a:lnSpc>
              <a:spcBef>
                <a:spcPts val="0"/>
              </a:spcBef>
              <a:buNone/>
            </a:pP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lnSpc>
                <a:spcPct val="200000"/>
              </a:lnSpc>
              <a:spcBef>
                <a:spcPts val="0"/>
              </a:spcBef>
              <a:buNone/>
            </a:pPr>
            <a:r>
              <a:rPr lang="en-US" sz="1200" i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l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es adjusted for age, sex, race/ethnicity, education level, annual household income, smoking status, alcohol use, daily hours sedentary, weekly physical activity level, daily calorie intake, and survey year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697055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AF77239-BBA4-43CE-23A5-738DF87A731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8000" y="76200"/>
            <a:ext cx="11176000" cy="6781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094551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76</TotalTime>
  <Words>105</Words>
  <Application>Microsoft Macintosh PowerPoint</Application>
  <PresentationFormat>Widescreen</PresentationFormat>
  <Paragraphs>6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Supplementary Figures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ci Winn</dc:creator>
  <cp:lastModifiedBy>Maci Winn</cp:lastModifiedBy>
  <cp:revision>165</cp:revision>
  <cp:lastPrinted>2021-09-29T20:55:13Z</cp:lastPrinted>
  <dcterms:created xsi:type="dcterms:W3CDTF">2021-06-28T18:58:33Z</dcterms:created>
  <dcterms:modified xsi:type="dcterms:W3CDTF">2022-05-02T01:32:57Z</dcterms:modified>
</cp:coreProperties>
</file>